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17205C-C1A0-4295-9301-71F130BE1FB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34F1CF-CE7A-46ED-AE94-F0F8280B1D1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121133-ACEB-47A9-8981-4E48F7BE535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55BA55-D1F6-49DD-B6CB-1A207E76982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0A0E46-6C0A-498B-A857-2D191F92456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A5624F-7BC9-4C92-982D-6562906FE1C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D88462-1679-4E5F-8EF8-2D581DE8CCF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436948-B3E9-49C0-B258-58D7B224F69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14E616-852D-4966-9920-1C46212DFA7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D7168F-2423-462D-864C-058C91B3F9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EE1827-6277-43AC-B95B-FC21AA6123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A9E497-F5E9-4EDC-8904-9572CEDDA3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CO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CO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CO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5EBE884-CF99-45A7-A2C3-6F79EA3B4C38}" type="slidenum">
              <a:rPr b="0" lang="es-CO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2 Gráfico" descr=""/>
          <p:cNvPicPr/>
          <p:nvPr/>
        </p:nvPicPr>
        <p:blipFill>
          <a:blip r:embed="rId1"/>
          <a:stretch/>
        </p:blipFill>
        <p:spPr>
          <a:xfrm>
            <a:off x="212760" y="1187280"/>
            <a:ext cx="6431040" cy="7486920"/>
          </a:xfrm>
          <a:prstGeom prst="rect">
            <a:avLst/>
          </a:prstGeom>
          <a:ln w="0">
            <a:noFill/>
          </a:ln>
        </p:spPr>
      </p:pic>
      <p:sp>
        <p:nvSpPr>
          <p:cNvPr id="42" name="5 CuadroTexto"/>
          <p:cNvSpPr/>
          <p:nvPr/>
        </p:nvSpPr>
        <p:spPr>
          <a:xfrm>
            <a:off x="500040" y="214200"/>
            <a:ext cx="5857920" cy="1067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Additional file 2.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 Title: Dotplot of homologies between common bean and soybean genomes.   Associations of markers from linkage groups B1 through B11 of common bean with sequences from chromosomes Gm01 through Gm20 of soybean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9-04T19:18:27Z</dcterms:created>
  <dc:creator>Andrea Carolina</dc:creator>
  <dc:description/>
  <dc:language>en-US</dc:language>
  <cp:lastModifiedBy>mblair</cp:lastModifiedBy>
  <dcterms:modified xsi:type="dcterms:W3CDTF">2009-12-05T18:04:42Z</dcterms:modified>
  <cp:revision>4</cp:revision>
  <dc:subject/>
  <dc:title>Diapositiva 1</dc:title>
</cp:coreProperties>
</file>